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250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97F9D8-9DA4-D4C3-5071-CE93010AF6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2B5918E-AF3B-CF20-F23F-02C60A0E43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B9FC95-7EFC-35B6-6FBA-E27AC008E1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7BB249-A5CA-5C0B-1415-35221B63E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69FCC0-4B49-0579-B012-ABC025DA0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851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7A53DF-84FA-7080-F2E4-EEE8C547F1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84F297-86E3-5800-AA37-45C06AAC5A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08F27D-3AC1-81CA-DDAC-91D38D8F6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1F2281-4796-EA07-73B1-DE3F4813B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EFD7AD9-DE31-EED5-1C57-A6913F413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22411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85A8CEA-F331-4FAB-F825-81E5C130E0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6BBC20D-C443-7C9E-2CBB-9F08CBDEC8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EF04AB-E007-B057-245D-38F59A7DE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9676C9-E007-A786-3903-ABB7FA1B2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62467F-9137-2EC5-0B00-288E26A2A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7027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2D192C-2B31-A67B-3149-0824D3EAFA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0F9172-CAED-5766-7629-1B7CE33CF2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5FA7F95-1F0D-3A59-01A3-0D3C559B6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AB762A1-F840-4ED3-7D2C-4FC266298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A6EF62-6049-6041-F32D-6084DDFA2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664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D9CDB66-5DF5-27E7-FF86-6104279D46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FA9434-0C09-A066-7FA2-1421DE94B4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105CD1-C584-FBD0-5000-36FD5C6DC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B6F57B-DB63-BF80-B8A5-9D06FF0E5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0B47AD-2107-C3F9-7FFD-461547C00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68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D80DD6-AF4F-8023-4B11-8954A17CE7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D70FA7-1732-B3B2-AB51-F55F3E552B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28F78B5-D219-22AC-BBD4-19B190E13F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5AE86A-61FD-A795-D1D2-2778B93C7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67CFCC-E05A-AC8B-D4F6-765066660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BD2A0A9-E291-3939-4987-67C28D0D4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759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A2A3ED-D304-D417-2E7F-7A91901AB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3B8D84-95ED-8609-D575-1BF74EA7C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6D57EC-D6A8-FA80-D23D-AB3E53DB37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BBCDBF1-0D4A-13FC-E004-D65821FC41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8C17B87-FA10-4EC3-FEE3-6D5F2526AB2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8E27506-5162-0193-AD17-656B15F20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E9B8325-9475-6C32-F342-6A7349BE0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9A89A6D-F5CB-FD62-63B4-0B0A19E91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4766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7F641B-5502-C7A5-F369-91DFA96A6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20C23F5-C7E7-FC49-EA10-33CAD5DA17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79E5F2E-E700-F88A-A2E6-A0DC8D1E4C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8B977B1-2721-E0E1-CD7E-352D042F3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467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EC9E0AB-87DD-4E43-819A-6CDD4A50F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25434BA-2347-60DE-529B-B2478CF3A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E26F54E-2C43-9571-68B5-474EFE061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2397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4D68B5-06B9-38CF-A585-F28685B76D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3B9D26C-97DC-7EB5-F642-4EC7EFFE3C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B368A1-3DA6-8E7F-4885-8B74840CDD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482F91E-02CD-17B7-EBEA-FA62056BB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120D5E-5D71-7DFB-E32B-26C74293A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8730428-ED1B-44EC-DEA1-24B193DC4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2587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774D6B-B230-12E2-5923-7312523453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CD7FE58-B8DB-5E20-FEF4-A377AAB7D9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2ACDEEE-5D8F-3855-3AF6-BE7FA0EBB5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8862C0-6925-5D8C-F537-478E46B88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71CD8D1-D9F0-F3B6-E446-FA51336F0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6514C2-86D7-DB73-1098-FB9BE1164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3880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EE71F5F-31FC-A647-DDF1-B2EBB5542B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2E3E45-706B-5017-73B6-67EA1C888F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90BA6D-3CDC-11D5-7217-7EAE2606EA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A4EF7-46EC-49FF-BBF2-A53150E11B5B}" type="datetimeFigureOut">
              <a:rPr lang="zh-CN" altLang="en-US" smtClean="0"/>
              <a:t>2023/6/1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438CE6-63AE-C7CD-7148-23E3B52D1C6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4C8341-E3CA-086C-8BE3-4D7CF0FAA9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634170-0B96-4000-9F87-CD7C1250A8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3434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75702755-7456-0CF3-1963-18B89F52E8B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4189" y="393621"/>
            <a:ext cx="3601212" cy="360121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9DE3B88-6542-6364-A990-C6D41BC4B4C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305" y="393621"/>
            <a:ext cx="3601212" cy="360121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ECC913D-9A42-FB57-F58C-A002D91BBE6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6367" y="446666"/>
            <a:ext cx="3601212" cy="3601212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8ED7AD8B-41E2-0882-13B5-83851AC1D352}"/>
              </a:ext>
            </a:extLst>
          </p:cNvPr>
          <p:cNvSpPr txBox="1"/>
          <p:nvPr/>
        </p:nvSpPr>
        <p:spPr>
          <a:xfrm>
            <a:off x="3177039" y="1381611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LR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F61CB7D-0E7B-EE64-2B7D-C9122DDBCD2F}"/>
              </a:ext>
            </a:extLst>
          </p:cNvPr>
          <p:cNvSpPr txBox="1"/>
          <p:nvPr/>
        </p:nvSpPr>
        <p:spPr>
          <a:xfrm>
            <a:off x="3177039" y="2503556"/>
            <a:ext cx="891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546FFA8-8C9B-85CF-B29B-71EAFB07099D}"/>
              </a:ext>
            </a:extLst>
          </p:cNvPr>
          <p:cNvSpPr txBox="1"/>
          <p:nvPr/>
        </p:nvSpPr>
        <p:spPr>
          <a:xfrm>
            <a:off x="2607652" y="574097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A95280C-66DA-9CBC-9B33-4FA84153EA36}"/>
              </a:ext>
            </a:extLst>
          </p:cNvPr>
          <p:cNvSpPr txBox="1"/>
          <p:nvPr/>
        </p:nvSpPr>
        <p:spPr>
          <a:xfrm>
            <a:off x="1811042" y="800740"/>
            <a:ext cx="11881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LR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2160delC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7B414AF-8190-07F2-E56D-68517385491D}"/>
              </a:ext>
            </a:extLst>
          </p:cNvPr>
          <p:cNvSpPr txBox="1"/>
          <p:nvPr/>
        </p:nvSpPr>
        <p:spPr>
          <a:xfrm>
            <a:off x="1715205" y="574097"/>
            <a:ext cx="594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54043C7-6CB7-1884-05DD-4131385A7CA5}"/>
              </a:ext>
            </a:extLst>
          </p:cNvPr>
          <p:cNvSpPr txBox="1"/>
          <p:nvPr/>
        </p:nvSpPr>
        <p:spPr>
          <a:xfrm>
            <a:off x="10388989" y="539622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C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9A9CF65-E677-9E0D-A0F5-79D7535DB309}"/>
              </a:ext>
            </a:extLst>
          </p:cNvPr>
          <p:cNvSpPr txBox="1"/>
          <p:nvPr/>
        </p:nvSpPr>
        <p:spPr>
          <a:xfrm>
            <a:off x="9579031" y="766265"/>
            <a:ext cx="11881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DLR</a:t>
            </a:r>
          </a:p>
          <a:p>
            <a:pPr algn="ctr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2160delC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F6E9027-4D7B-92F4-502A-EEBAAF8C489C}"/>
              </a:ext>
            </a:extLst>
          </p:cNvPr>
          <p:cNvSpPr txBox="1"/>
          <p:nvPr/>
        </p:nvSpPr>
        <p:spPr>
          <a:xfrm>
            <a:off x="9463172" y="539622"/>
            <a:ext cx="5949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B163CD4-00E2-447B-322B-EAA2FA0544AD}"/>
              </a:ext>
            </a:extLst>
          </p:cNvPr>
          <p:cNvSpPr txBox="1"/>
          <p:nvPr/>
        </p:nvSpPr>
        <p:spPr>
          <a:xfrm>
            <a:off x="8939232" y="820507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CA8DA68-4E55-3483-3EC6-03A460F8F188}"/>
              </a:ext>
            </a:extLst>
          </p:cNvPr>
          <p:cNvSpPr txBox="1"/>
          <p:nvPr/>
        </p:nvSpPr>
        <p:spPr>
          <a:xfrm>
            <a:off x="10740076" y="820507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1DBE673A-6387-0676-D697-362EE7C4BA77}"/>
              </a:ext>
            </a:extLst>
          </p:cNvPr>
          <p:cNvSpPr txBox="1"/>
          <p:nvPr/>
        </p:nvSpPr>
        <p:spPr>
          <a:xfrm>
            <a:off x="4990805" y="800740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5260160-3925-FB29-E8A6-9152EED616E3}"/>
              </a:ext>
            </a:extLst>
          </p:cNvPr>
          <p:cNvSpPr txBox="1"/>
          <p:nvPr/>
        </p:nvSpPr>
        <p:spPr>
          <a:xfrm>
            <a:off x="6685181" y="800739"/>
            <a:ext cx="8034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EA05510-7E56-C27D-6619-A755BAD4F82E}"/>
              </a:ext>
            </a:extLst>
          </p:cNvPr>
          <p:cNvSpPr txBox="1"/>
          <p:nvPr/>
        </p:nvSpPr>
        <p:spPr>
          <a:xfrm>
            <a:off x="7180038" y="1207857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C56371A-1BB9-91CF-B1FB-7D5B240E508E}"/>
              </a:ext>
            </a:extLst>
          </p:cNvPr>
          <p:cNvSpPr txBox="1"/>
          <p:nvPr/>
        </p:nvSpPr>
        <p:spPr>
          <a:xfrm>
            <a:off x="7177867" y="1461086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D95B9F6-85FA-6452-6AF3-70D09867250C}"/>
              </a:ext>
            </a:extLst>
          </p:cNvPr>
          <p:cNvSpPr txBox="1"/>
          <p:nvPr/>
        </p:nvSpPr>
        <p:spPr>
          <a:xfrm>
            <a:off x="7175696" y="1768863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FA60672-EA2C-E7B1-A290-22411FCFA4AC}"/>
              </a:ext>
            </a:extLst>
          </p:cNvPr>
          <p:cNvSpPr txBox="1"/>
          <p:nvPr/>
        </p:nvSpPr>
        <p:spPr>
          <a:xfrm>
            <a:off x="7175696" y="2040338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8F144DC7-FC0F-D0CD-F947-E293957ACAF3}"/>
              </a:ext>
            </a:extLst>
          </p:cNvPr>
          <p:cNvSpPr txBox="1"/>
          <p:nvPr/>
        </p:nvSpPr>
        <p:spPr>
          <a:xfrm>
            <a:off x="7186418" y="2420182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210C428-0E2B-5F22-EDD2-C39503F0E403}"/>
              </a:ext>
            </a:extLst>
          </p:cNvPr>
          <p:cNvSpPr txBox="1"/>
          <p:nvPr/>
        </p:nvSpPr>
        <p:spPr>
          <a:xfrm>
            <a:off x="7186417" y="280002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F4B3A81-3D27-3925-E4ED-1906D4F65797}"/>
              </a:ext>
            </a:extLst>
          </p:cNvPr>
          <p:cNvSpPr txBox="1"/>
          <p:nvPr/>
        </p:nvSpPr>
        <p:spPr>
          <a:xfrm>
            <a:off x="8433710" y="1306865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6EE8A48-9DA0-5B8E-7112-02D529EA602D}"/>
              </a:ext>
            </a:extLst>
          </p:cNvPr>
          <p:cNvSpPr txBox="1"/>
          <p:nvPr/>
        </p:nvSpPr>
        <p:spPr>
          <a:xfrm>
            <a:off x="8431539" y="1560094"/>
            <a:ext cx="7232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C80546F5-FDB7-0743-70FB-436441236A45}"/>
              </a:ext>
            </a:extLst>
          </p:cNvPr>
          <p:cNvSpPr txBox="1"/>
          <p:nvPr/>
        </p:nvSpPr>
        <p:spPr>
          <a:xfrm>
            <a:off x="8429368" y="1867871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B4D4883-D558-C23A-9331-16D909CAF4C5}"/>
              </a:ext>
            </a:extLst>
          </p:cNvPr>
          <p:cNvSpPr txBox="1"/>
          <p:nvPr/>
        </p:nvSpPr>
        <p:spPr>
          <a:xfrm>
            <a:off x="8429368" y="2139346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2785935-93FD-C73D-DD4A-713BBDF2E275}"/>
              </a:ext>
            </a:extLst>
          </p:cNvPr>
          <p:cNvSpPr txBox="1"/>
          <p:nvPr/>
        </p:nvSpPr>
        <p:spPr>
          <a:xfrm>
            <a:off x="8440090" y="2519190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571DCE4-2587-0C2C-869F-D2D9915E2884}"/>
              </a:ext>
            </a:extLst>
          </p:cNvPr>
          <p:cNvSpPr txBox="1"/>
          <p:nvPr/>
        </p:nvSpPr>
        <p:spPr>
          <a:xfrm>
            <a:off x="8440089" y="289903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kd  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31B3B01-7865-8878-7F2F-22C3C0D222C2}"/>
              </a:ext>
            </a:extLst>
          </p:cNvPr>
          <p:cNvSpPr txBox="1"/>
          <p:nvPr/>
        </p:nvSpPr>
        <p:spPr>
          <a:xfrm>
            <a:off x="827918" y="3528978"/>
            <a:ext cx="334578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hemiluminescence/fluorescence 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osure (1 minute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D0C4FE8-D207-4455-4361-AB4AEB1A159A}"/>
              </a:ext>
            </a:extLst>
          </p:cNvPr>
          <p:cNvSpPr txBox="1"/>
          <p:nvPr/>
        </p:nvSpPr>
        <p:spPr>
          <a:xfrm>
            <a:off x="5313826" y="3524787"/>
            <a:ext cx="18004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hite light mode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10 second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B0FC9D7-0136-A4F7-70F4-766E2D79A980}"/>
              </a:ext>
            </a:extLst>
          </p:cNvPr>
          <p:cNvSpPr txBox="1"/>
          <p:nvPr/>
        </p:nvSpPr>
        <p:spPr>
          <a:xfrm>
            <a:off x="9781490" y="3628190"/>
            <a:ext cx="783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erge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2897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48</Words>
  <Application>Microsoft Office PowerPoint</Application>
  <PresentationFormat>宽屏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胡 豪畅</dc:creator>
  <cp:lastModifiedBy>胡 豪畅</cp:lastModifiedBy>
  <cp:revision>1</cp:revision>
  <dcterms:created xsi:type="dcterms:W3CDTF">2023-06-12T08:34:41Z</dcterms:created>
  <dcterms:modified xsi:type="dcterms:W3CDTF">2023-06-12T08:51:49Z</dcterms:modified>
</cp:coreProperties>
</file>